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9"/>
  </p:notesMasterIdLst>
  <p:sldIdLst>
    <p:sldId id="329" r:id="rId2"/>
    <p:sldId id="338" r:id="rId3"/>
    <p:sldId id="331" r:id="rId4"/>
    <p:sldId id="321" r:id="rId5"/>
    <p:sldId id="326" r:id="rId6"/>
    <p:sldId id="333" r:id="rId7"/>
    <p:sldId id="334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556"/>
    <p:restoredTop sz="96311"/>
  </p:normalViewPr>
  <p:slideViewPr>
    <p:cSldViewPr snapToGrid="0" snapToObjects="1">
      <p:cViewPr varScale="1">
        <p:scale>
          <a:sx n="86" d="100"/>
          <a:sy n="86" d="100"/>
        </p:scale>
        <p:origin x="319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E165BF-4918-9D4D-AB80-CE19E3860B9A}" type="datetimeFigureOut">
              <a:rPr lang="en-US" smtClean="0"/>
              <a:t>8/1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1EABCE-1858-AD44-BCEE-E23D3DDFF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506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ood intake</a:t>
            </a:r>
          </a:p>
          <a:p>
            <a:endParaRPr lang="en-US" dirty="0"/>
          </a:p>
          <a:p>
            <a:r>
              <a:rPr lang="en-US" dirty="0"/>
              <a:t>Animal weight barrel feeder </a:t>
            </a:r>
            <a:r>
              <a:rPr lang="en-US" dirty="0" err="1"/>
              <a:t>jul</a:t>
            </a:r>
            <a:r>
              <a:rPr lang="en-US" dirty="0"/>
              <a:t> 2024 / Data for IEC feeding paper / Feeding and gut rhythmicity paper / Dropbox</a:t>
            </a:r>
          </a:p>
          <a:p>
            <a:endParaRPr lang="en-US" dirty="0"/>
          </a:p>
          <a:p>
            <a:r>
              <a:rPr lang="en-US" dirty="0"/>
              <a:t>Data: </a:t>
            </a:r>
          </a:p>
          <a:p>
            <a:endParaRPr lang="en-US" dirty="0"/>
          </a:p>
          <a:p>
            <a:r>
              <a:rPr lang="en-US" dirty="0"/>
              <a:t>Panel A: Food weights analysis </a:t>
            </a:r>
            <a:r>
              <a:rPr lang="en-US" dirty="0" err="1"/>
              <a:t>af</a:t>
            </a:r>
            <a:r>
              <a:rPr lang="en-US" dirty="0"/>
              <a:t> fed 2023 – data for Felicity’s paper – Dropbox. </a:t>
            </a:r>
          </a:p>
          <a:p>
            <a:r>
              <a:rPr lang="en-US" dirty="0"/>
              <a:t>Panel B and C: Animal weight barrel feeder </a:t>
            </a:r>
            <a:r>
              <a:rPr lang="en-US" dirty="0" err="1"/>
              <a:t>jul</a:t>
            </a:r>
            <a:r>
              <a:rPr lang="en-US" dirty="0"/>
              <a:t> 2024 / Data for IEC feeding paper / Feeding and gut rhythmicity paper / Dropbox</a:t>
            </a:r>
          </a:p>
          <a:p>
            <a:r>
              <a:rPr lang="en-US" dirty="0"/>
              <a:t>Panel D and E and F: </a:t>
            </a:r>
            <a:r>
              <a:rPr lang="en-US" dirty="0" err="1"/>
              <a:t>Phenomaster</a:t>
            </a:r>
            <a:r>
              <a:rPr lang="en-US" dirty="0"/>
              <a:t> data – Dropbox </a:t>
            </a:r>
            <a:r>
              <a:rPr lang="en-US" dirty="0" err="1"/>
              <a:t>Phenomaster</a:t>
            </a:r>
            <a:r>
              <a:rPr lang="en-US" dirty="0"/>
              <a:t> ARF and Ad lib - Day 2 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5A663-B711-7546-9282-A9F10648398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9060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D overall expression 202412 analysis</a:t>
            </a:r>
          </a:p>
          <a:p>
            <a:r>
              <a:rPr lang="en-US" dirty="0"/>
              <a:t>Feeding and gut rhythmicity paper</a:t>
            </a:r>
          </a:p>
          <a:p>
            <a:endParaRPr lang="en-US" dirty="0"/>
          </a:p>
          <a:p>
            <a:r>
              <a:rPr lang="en-US" dirty="0"/>
              <a:t>“not owing to alterations in the </a:t>
            </a:r>
            <a:r>
              <a:rPr lang="en-US" dirty="0" err="1"/>
              <a:t>magnitutde</a:t>
            </a:r>
            <a:r>
              <a:rPr lang="en-US" dirty="0"/>
              <a:t> of expression change between treatment groups.</a:t>
            </a:r>
          </a:p>
          <a:p>
            <a:endParaRPr lang="en-US" dirty="0"/>
          </a:p>
          <a:p>
            <a:r>
              <a:rPr lang="en-US" dirty="0"/>
              <a:t>Mean expression level were compared in ad libitum and interval fed samples, Error bars show median and interquartile range (yes), distributions compared by </a:t>
            </a:r>
            <a:r>
              <a:rPr lang="en-US" dirty="0" err="1"/>
              <a:t>Welche’s</a:t>
            </a:r>
            <a:r>
              <a:rPr lang="en-US" dirty="0"/>
              <a:t> t test. </a:t>
            </a:r>
          </a:p>
          <a:p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srgbClr val="FF0000"/>
                </a:solidFill>
              </a:rPr>
              <a:t>Clock genes - </a:t>
            </a:r>
            <a:r>
              <a:rPr lang="en-US" dirty="0"/>
              <a:t>Dropbox/Data for Felicity’s paper/IEC RNA </a:t>
            </a:r>
            <a:r>
              <a:rPr lang="en-US" dirty="0" err="1"/>
              <a:t>seq</a:t>
            </a:r>
            <a:r>
              <a:rPr lang="en-US" dirty="0"/>
              <a:t> ARF some genes plotted. – now correct and data values from Polly’s JTK. Output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5A663-B711-7546-9282-A9F10648398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97829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Liver qPCR ARF July 2022 – Data for IEC feeding paper – feeding and gut rhythmicity paper</a:t>
            </a:r>
          </a:p>
          <a:p>
            <a:endParaRPr lang="en-US" dirty="0"/>
          </a:p>
          <a:p>
            <a:r>
              <a:rPr lang="en-US" dirty="0"/>
              <a:t>Clock genes – </a:t>
            </a:r>
            <a:r>
              <a:rPr lang="en-US" dirty="0" err="1"/>
              <a:t>Taqman</a:t>
            </a:r>
            <a:r>
              <a:rPr lang="en-US" dirty="0"/>
              <a:t> – normalized to B actin</a:t>
            </a:r>
          </a:p>
          <a:p>
            <a:endParaRPr lang="en-US" dirty="0"/>
          </a:p>
          <a:p>
            <a:r>
              <a:rPr lang="en-US" dirty="0"/>
              <a:t>Per2 2 way ANOVA. Feeding NS, Time **** Interaction NS</a:t>
            </a:r>
          </a:p>
          <a:p>
            <a:r>
              <a:rPr lang="en-US" dirty="0"/>
              <a:t>Bmal1 two way ANOVA, Feeding NS, time **** interaction ***</a:t>
            </a:r>
          </a:p>
          <a:p>
            <a:r>
              <a:rPr lang="en-US" dirty="0"/>
              <a:t>REV-</a:t>
            </a:r>
            <a:r>
              <a:rPr lang="en-US" dirty="0" err="1"/>
              <a:t>Erb</a:t>
            </a:r>
            <a:r>
              <a:rPr lang="en-US" dirty="0"/>
              <a:t> alpha 2 way ANOVA Feeding NS, Time **** Interaction I</a:t>
            </a:r>
          </a:p>
          <a:p>
            <a:endParaRPr lang="en-US" dirty="0"/>
          </a:p>
          <a:p>
            <a:r>
              <a:rPr lang="en-US" dirty="0"/>
              <a:t>N = 3-5</a:t>
            </a:r>
          </a:p>
          <a:p>
            <a:r>
              <a:rPr lang="en-US" dirty="0"/>
              <a:t>HK gene b acti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5A663-B711-7546-9282-A9F10648398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719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Loss pathway analysis – Plotted log10 P value (NOT </a:t>
            </a:r>
            <a:r>
              <a:rPr lang="en-US" dirty="0" err="1"/>
              <a:t>P.adj</a:t>
            </a:r>
            <a:r>
              <a:rPr lang="en-US" dirty="0"/>
              <a:t>)  </a:t>
            </a:r>
            <a:r>
              <a:rPr lang="en-US" dirty="0" err="1"/>
              <a:t>Paj</a:t>
            </a:r>
            <a:r>
              <a:rPr lang="en-US" dirty="0"/>
              <a:t> all &gt;0.05 so keep in supplementary.</a:t>
            </a:r>
          </a:p>
          <a:p>
            <a:endParaRPr lang="en-US" dirty="0">
              <a:solidFill>
                <a:srgbClr val="FF0000"/>
              </a:solidFill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olcano plot ARF IEC RNA Seq, JG2024 comparisons no time</a:t>
            </a:r>
          </a:p>
          <a:p>
            <a:endParaRPr lang="en-US" dirty="0">
              <a:solidFill>
                <a:srgbClr val="FF0000"/>
              </a:solidFill>
            </a:endParaRPr>
          </a:p>
          <a:p>
            <a:r>
              <a:rPr lang="en-US" dirty="0">
                <a:solidFill>
                  <a:srgbClr val="FF0000"/>
                </a:solidFill>
              </a:rPr>
              <a:t>Data for table of DE genes, paired gene list, JG 2024 comparisons no tim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5A663-B711-7546-9282-A9F10648398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5107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lative abundance – added up from </a:t>
            </a:r>
            <a:r>
              <a:rPr lang="en-US" dirty="0" err="1"/>
              <a:t>phyloseq</a:t>
            </a:r>
            <a:endParaRPr lang="en-US" dirty="0"/>
          </a:p>
          <a:p>
            <a:r>
              <a:rPr lang="en-US" dirty="0"/>
              <a:t>Individual OUT plots “species plotted sine wave </a:t>
            </a:r>
            <a:r>
              <a:rPr lang="en-US" dirty="0" err="1"/>
              <a:t>rel</a:t>
            </a:r>
            <a:r>
              <a:rPr lang="en-US" dirty="0"/>
              <a:t> </a:t>
            </a:r>
            <a:r>
              <a:rPr lang="en-US" dirty="0" err="1"/>
              <a:t>abund</a:t>
            </a:r>
            <a:r>
              <a:rPr lang="en-US" dirty="0"/>
              <a:t>”</a:t>
            </a:r>
          </a:p>
          <a:p>
            <a:endParaRPr lang="en-US" dirty="0"/>
          </a:p>
          <a:p>
            <a:r>
              <a:rPr lang="en-US" dirty="0"/>
              <a:t>OTUs in files with * arrhythmic and ad libitum, total or relative</a:t>
            </a:r>
          </a:p>
          <a:p>
            <a:endParaRPr lang="en-US" dirty="0"/>
          </a:p>
          <a:p>
            <a:r>
              <a:rPr lang="en-US" dirty="0"/>
              <a:t>Where’s the data</a:t>
            </a:r>
          </a:p>
          <a:p>
            <a:r>
              <a:rPr lang="en-US" dirty="0"/>
              <a:t>A – Dropbox, Julie Gibbs, ARF </a:t>
            </a:r>
            <a:r>
              <a:rPr lang="en-US" dirty="0" err="1"/>
              <a:t>faecal</a:t>
            </a:r>
            <a:r>
              <a:rPr lang="en-US" dirty="0"/>
              <a:t> 16S rRNA sequencing Run 1, *Liverpool new analysis 2024, *</a:t>
            </a:r>
            <a:r>
              <a:rPr lang="en-US" dirty="0" err="1"/>
              <a:t>Phyloseq</a:t>
            </a:r>
            <a:r>
              <a:rPr lang="en-US" dirty="0"/>
              <a:t> 17072024, Shannon index plots 18072024.</a:t>
            </a:r>
          </a:p>
          <a:p>
            <a:r>
              <a:rPr lang="en-US" dirty="0"/>
              <a:t>B- Dropbox, Julie Gibbs, ARF, </a:t>
            </a:r>
            <a:r>
              <a:rPr lang="en-US" dirty="0" err="1"/>
              <a:t>faecal</a:t>
            </a:r>
            <a:r>
              <a:rPr lang="en-US" dirty="0"/>
              <a:t> 16s rRNA sequencing Run 1, *Liverpool new analysis 2024, *</a:t>
            </a:r>
            <a:r>
              <a:rPr lang="en-US" dirty="0" err="1"/>
              <a:t>phyloseq</a:t>
            </a:r>
            <a:r>
              <a:rPr lang="en-US" dirty="0"/>
              <a:t> 17072024, 25072024 phyla by time </a:t>
            </a:r>
          </a:p>
          <a:p>
            <a:r>
              <a:rPr lang="en-US" dirty="0"/>
              <a:t>C Dropbox, Julie Gibbs, ARF, </a:t>
            </a:r>
            <a:r>
              <a:rPr lang="en-US" dirty="0" err="1"/>
              <a:t>faecal</a:t>
            </a:r>
            <a:r>
              <a:rPr lang="en-US" dirty="0"/>
              <a:t> 16s rRNA sequencing Run 1, *Liverpool new </a:t>
            </a:r>
            <a:r>
              <a:rPr lang="en-US" dirty="0" err="1"/>
              <a:t>anlaysis</a:t>
            </a:r>
            <a:r>
              <a:rPr lang="en-US" dirty="0"/>
              <a:t> 2024, *</a:t>
            </a:r>
            <a:r>
              <a:rPr lang="en-US" dirty="0" err="1"/>
              <a:t>Phyloseq</a:t>
            </a:r>
            <a:r>
              <a:rPr lang="en-US" dirty="0"/>
              <a:t> 17072024, Species plotted sine wave </a:t>
            </a:r>
            <a:r>
              <a:rPr lang="en-US" dirty="0" err="1"/>
              <a:t>rel</a:t>
            </a:r>
            <a:r>
              <a:rPr lang="en-US" dirty="0"/>
              <a:t> </a:t>
            </a:r>
            <a:r>
              <a:rPr lang="en-US" dirty="0" err="1"/>
              <a:t>abund.prism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5A663-B711-7546-9282-A9F10648398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45886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JTK cycle analysis 18102024 scale SCFA levels</a:t>
            </a:r>
          </a:p>
          <a:p>
            <a:r>
              <a:rPr lang="en-US" dirty="0"/>
              <a:t>N=5 (1 value removed in one sample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5A663-B711-7546-9282-A9F10648398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23273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A5A663-B711-7546-9282-A9F106483982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1476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349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472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391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215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585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24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435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161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215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861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184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BC646-B249-A543-82FE-B029D67FAC6B}" type="datetimeFigureOut">
              <a:rPr lang="en-US" smtClean="0"/>
              <a:t>8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9E701-CD8B-5147-89A4-3D07B2623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509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image" Target="../media/image20.tif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12" Type="http://schemas.openxmlformats.org/officeDocument/2006/relationships/image" Target="../media/image19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emf"/><Relationship Id="rId5" Type="http://schemas.openxmlformats.org/officeDocument/2006/relationships/image" Target="../media/image12.emf"/><Relationship Id="rId15" Type="http://schemas.openxmlformats.org/officeDocument/2006/relationships/image" Target="../media/image2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Relationship Id="rId14" Type="http://schemas.openxmlformats.org/officeDocument/2006/relationships/image" Target="../media/image2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emf"/><Relationship Id="rId5" Type="http://schemas.openxmlformats.org/officeDocument/2006/relationships/image" Target="../media/image31.emf"/><Relationship Id="rId10" Type="http://schemas.openxmlformats.org/officeDocument/2006/relationships/image" Target="../media/image36.emf"/><Relationship Id="rId4" Type="http://schemas.openxmlformats.org/officeDocument/2006/relationships/image" Target="../media/image30.emf"/><Relationship Id="rId9" Type="http://schemas.openxmlformats.org/officeDocument/2006/relationships/image" Target="../media/image35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42F0514-52C4-A167-46EF-ABB4C3A75B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68" y="544092"/>
            <a:ext cx="2857973" cy="181491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DBA669D-122A-8D46-AF31-148E2E8EB8CF}"/>
              </a:ext>
            </a:extLst>
          </p:cNvPr>
          <p:cNvSpPr txBox="1"/>
          <p:nvPr/>
        </p:nvSpPr>
        <p:spPr>
          <a:xfrm>
            <a:off x="-30259" y="-14561"/>
            <a:ext cx="23186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386BBC6-62C4-DB41-8A99-FCA06DD5BA96}"/>
              </a:ext>
            </a:extLst>
          </p:cNvPr>
          <p:cNvSpPr txBox="1"/>
          <p:nvPr/>
        </p:nvSpPr>
        <p:spPr>
          <a:xfrm>
            <a:off x="-14271" y="258047"/>
            <a:ext cx="7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02A158C-5FDA-C14D-B965-CD7C1BDC3D69}"/>
              </a:ext>
            </a:extLst>
          </p:cNvPr>
          <p:cNvSpPr txBox="1"/>
          <p:nvPr/>
        </p:nvSpPr>
        <p:spPr>
          <a:xfrm>
            <a:off x="2719882" y="231660"/>
            <a:ext cx="7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5C70C1C-6E98-134C-8B8B-16217806FEB5}"/>
              </a:ext>
            </a:extLst>
          </p:cNvPr>
          <p:cNvSpPr txBox="1"/>
          <p:nvPr/>
        </p:nvSpPr>
        <p:spPr>
          <a:xfrm>
            <a:off x="4914403" y="223816"/>
            <a:ext cx="7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13D869-D10C-AA47-AC49-50F6548AED3F}"/>
              </a:ext>
            </a:extLst>
          </p:cNvPr>
          <p:cNvSpPr txBox="1"/>
          <p:nvPr/>
        </p:nvSpPr>
        <p:spPr>
          <a:xfrm>
            <a:off x="147552" y="2409668"/>
            <a:ext cx="7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6EFA178-4769-4A4F-BAA4-221C294F04DD}"/>
              </a:ext>
            </a:extLst>
          </p:cNvPr>
          <p:cNvSpPr txBox="1"/>
          <p:nvPr/>
        </p:nvSpPr>
        <p:spPr>
          <a:xfrm>
            <a:off x="92224" y="3760674"/>
            <a:ext cx="7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27E41D-B70E-FD40-91DA-8C9675ECFCA0}"/>
              </a:ext>
            </a:extLst>
          </p:cNvPr>
          <p:cNvSpPr txBox="1"/>
          <p:nvPr/>
        </p:nvSpPr>
        <p:spPr>
          <a:xfrm>
            <a:off x="92223" y="5121677"/>
            <a:ext cx="7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74F035B-B7B5-C349-98C4-E024476A4375}"/>
              </a:ext>
            </a:extLst>
          </p:cNvPr>
          <p:cNvSpPr txBox="1"/>
          <p:nvPr/>
        </p:nvSpPr>
        <p:spPr>
          <a:xfrm>
            <a:off x="688422" y="1494947"/>
            <a:ext cx="670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D3171CE-817B-124F-B4B8-0A7BCE7B312A}"/>
              </a:ext>
            </a:extLst>
          </p:cNvPr>
          <p:cNvSpPr txBox="1"/>
          <p:nvPr/>
        </p:nvSpPr>
        <p:spPr>
          <a:xfrm>
            <a:off x="873166" y="1328665"/>
            <a:ext cx="670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456AF7A-B34F-7200-ADD9-36682E26F3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16294" y="599717"/>
            <a:ext cx="2551747" cy="175432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459F0FE-B75C-CFFE-13AC-A75CA9AD4C1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01709" y="339692"/>
            <a:ext cx="1814917" cy="1814917"/>
          </a:xfrm>
          <a:prstGeom prst="rect">
            <a:avLst/>
          </a:prstGeom>
        </p:spPr>
      </p:pic>
      <p:sp>
        <p:nvSpPr>
          <p:cNvPr id="31" name="Triangle 30">
            <a:extLst>
              <a:ext uri="{FF2B5EF4-FFF2-40B4-BE49-F238E27FC236}">
                <a16:creationId xmlns:a16="http://schemas.microsoft.com/office/drawing/2014/main" id="{3D05A6B8-5739-E44B-96E8-F53F9BD11694}"/>
              </a:ext>
            </a:extLst>
          </p:cNvPr>
          <p:cNvSpPr/>
          <p:nvPr/>
        </p:nvSpPr>
        <p:spPr>
          <a:xfrm rot="10800000" flipH="1">
            <a:off x="2768872" y="6272859"/>
            <a:ext cx="45719" cy="797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Triangle 31">
            <a:extLst>
              <a:ext uri="{FF2B5EF4-FFF2-40B4-BE49-F238E27FC236}">
                <a16:creationId xmlns:a16="http://schemas.microsoft.com/office/drawing/2014/main" id="{C9AF02A9-260E-2245-9C9D-28EF10305CF2}"/>
              </a:ext>
            </a:extLst>
          </p:cNvPr>
          <p:cNvSpPr/>
          <p:nvPr/>
        </p:nvSpPr>
        <p:spPr>
          <a:xfrm rot="10800000" flipH="1">
            <a:off x="2946858" y="6272369"/>
            <a:ext cx="45719" cy="797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riangle 32">
            <a:extLst>
              <a:ext uri="{FF2B5EF4-FFF2-40B4-BE49-F238E27FC236}">
                <a16:creationId xmlns:a16="http://schemas.microsoft.com/office/drawing/2014/main" id="{013C9973-C1FC-1543-9185-1C4C803F302E}"/>
              </a:ext>
            </a:extLst>
          </p:cNvPr>
          <p:cNvSpPr/>
          <p:nvPr/>
        </p:nvSpPr>
        <p:spPr>
          <a:xfrm rot="10800000" flipH="1">
            <a:off x="3963503" y="6272366"/>
            <a:ext cx="45719" cy="797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riangle 33">
            <a:extLst>
              <a:ext uri="{FF2B5EF4-FFF2-40B4-BE49-F238E27FC236}">
                <a16:creationId xmlns:a16="http://schemas.microsoft.com/office/drawing/2014/main" id="{DD3DB8F0-84F9-F940-8BC4-CC3C6098439F}"/>
              </a:ext>
            </a:extLst>
          </p:cNvPr>
          <p:cNvSpPr/>
          <p:nvPr/>
        </p:nvSpPr>
        <p:spPr>
          <a:xfrm rot="10800000" flipH="1">
            <a:off x="3109655" y="6272367"/>
            <a:ext cx="45719" cy="797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riangle 34">
            <a:extLst>
              <a:ext uri="{FF2B5EF4-FFF2-40B4-BE49-F238E27FC236}">
                <a16:creationId xmlns:a16="http://schemas.microsoft.com/office/drawing/2014/main" id="{2BBD36BF-E23C-8D4E-92DB-909CBDEFEAE7}"/>
              </a:ext>
            </a:extLst>
          </p:cNvPr>
          <p:cNvSpPr/>
          <p:nvPr/>
        </p:nvSpPr>
        <p:spPr>
          <a:xfrm rot="10800000" flipH="1">
            <a:off x="3296250" y="6272367"/>
            <a:ext cx="45719" cy="797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riangle 35">
            <a:extLst>
              <a:ext uri="{FF2B5EF4-FFF2-40B4-BE49-F238E27FC236}">
                <a16:creationId xmlns:a16="http://schemas.microsoft.com/office/drawing/2014/main" id="{7439BB0D-1988-E942-9340-63FDF40B12C9}"/>
              </a:ext>
            </a:extLst>
          </p:cNvPr>
          <p:cNvSpPr/>
          <p:nvPr/>
        </p:nvSpPr>
        <p:spPr>
          <a:xfrm rot="10800000" flipH="1">
            <a:off x="3457904" y="6272366"/>
            <a:ext cx="45719" cy="797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riangle 36">
            <a:extLst>
              <a:ext uri="{FF2B5EF4-FFF2-40B4-BE49-F238E27FC236}">
                <a16:creationId xmlns:a16="http://schemas.microsoft.com/office/drawing/2014/main" id="{8EDD3134-08E3-0647-9662-074F02EDA51C}"/>
              </a:ext>
            </a:extLst>
          </p:cNvPr>
          <p:cNvSpPr/>
          <p:nvPr/>
        </p:nvSpPr>
        <p:spPr>
          <a:xfrm rot="10800000" flipH="1">
            <a:off x="3621639" y="6273484"/>
            <a:ext cx="45719" cy="797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riangle 37">
            <a:extLst>
              <a:ext uri="{FF2B5EF4-FFF2-40B4-BE49-F238E27FC236}">
                <a16:creationId xmlns:a16="http://schemas.microsoft.com/office/drawing/2014/main" id="{688C42E2-A9FF-8D4B-A209-D5DD9373B3AC}"/>
              </a:ext>
            </a:extLst>
          </p:cNvPr>
          <p:cNvSpPr/>
          <p:nvPr/>
        </p:nvSpPr>
        <p:spPr>
          <a:xfrm rot="10800000" flipH="1">
            <a:off x="3798687" y="6272366"/>
            <a:ext cx="45719" cy="79775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F949B77-9C38-8C48-B158-DA111FD536F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78220" y="2453873"/>
            <a:ext cx="1829183" cy="132615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F3FE123-6054-0341-9D7E-9450D8608D9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2960" y="3867422"/>
            <a:ext cx="1931207" cy="13581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8DBF691-FE64-6349-9154-6E0F48E35B9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2960" y="2420165"/>
            <a:ext cx="2014624" cy="133795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9DC458A-1CAF-EA4C-8112-FE60A338B19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39738" y="3802413"/>
            <a:ext cx="1906146" cy="147215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054D41B-830A-D74C-8B75-33F6B9BE66D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68366" y="5244894"/>
            <a:ext cx="1937640" cy="143252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44C4133-1364-D743-A591-599EB0E653F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5643" y="5241715"/>
            <a:ext cx="1941941" cy="1435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750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6EF817CC-BDBE-B14A-A68C-E2DA46584940}"/>
              </a:ext>
            </a:extLst>
          </p:cNvPr>
          <p:cNvSpPr txBox="1"/>
          <p:nvPr/>
        </p:nvSpPr>
        <p:spPr>
          <a:xfrm>
            <a:off x="-37270" y="-20102"/>
            <a:ext cx="60579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68F10D1-5E43-FE4E-A0ED-ABEC7DCFCE0A}"/>
              </a:ext>
            </a:extLst>
          </p:cNvPr>
          <p:cNvGrpSpPr/>
          <p:nvPr/>
        </p:nvGrpSpPr>
        <p:grpSpPr>
          <a:xfrm>
            <a:off x="1746023" y="191528"/>
            <a:ext cx="5001862" cy="3037131"/>
            <a:chOff x="387100" y="-1419002"/>
            <a:chExt cx="5001862" cy="3037131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0ACC062-0A6B-2245-990B-2D3FC7E666FB}"/>
                </a:ext>
              </a:extLst>
            </p:cNvPr>
            <p:cNvSpPr txBox="1"/>
            <p:nvPr/>
          </p:nvSpPr>
          <p:spPr>
            <a:xfrm>
              <a:off x="4747884" y="105273"/>
              <a:ext cx="4711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oss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409BE940-CD48-4D44-B279-E7BB1264AE7D}"/>
                </a:ext>
              </a:extLst>
            </p:cNvPr>
            <p:cNvGrpSpPr/>
            <p:nvPr/>
          </p:nvGrpSpPr>
          <p:grpSpPr>
            <a:xfrm>
              <a:off x="387100" y="-1419002"/>
              <a:ext cx="5001862" cy="3037131"/>
              <a:chOff x="355687" y="-3623187"/>
              <a:chExt cx="5001862" cy="303713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03B93B14-1044-D848-94CA-90A783508B28}"/>
                  </a:ext>
                </a:extLst>
              </p:cNvPr>
              <p:cNvSpPr txBox="1"/>
              <p:nvPr/>
            </p:nvSpPr>
            <p:spPr>
              <a:xfrm>
                <a:off x="3581836" y="-3623187"/>
                <a:ext cx="55046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ame</a:t>
                </a:r>
              </a:p>
            </p:txBody>
          </p:sp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19F7752E-9A18-DB41-8DA4-4785CD73BA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284967" y="-3457606"/>
                <a:ext cx="1022592" cy="1354771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E2442B4F-0128-244A-85F1-36B544A519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193984" y="-3410448"/>
                <a:ext cx="1053843" cy="1362612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CD85D47-CED4-0844-AE44-9CC5DD50DDA7}"/>
                  </a:ext>
                </a:extLst>
              </p:cNvPr>
              <p:cNvSpPr txBox="1"/>
              <p:nvPr/>
            </p:nvSpPr>
            <p:spPr>
              <a:xfrm>
                <a:off x="4703427" y="-3622396"/>
                <a:ext cx="6541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hange</a:t>
                </a:r>
              </a:p>
            </p:txBody>
          </p:sp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2E8ED52F-7D7A-8649-8BAE-1D82E33579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198837" y="-1975801"/>
                <a:ext cx="1048990" cy="1389745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FB6AEED-BD1B-0A43-96BC-81AFEA30B57B}"/>
                  </a:ext>
                </a:extLst>
              </p:cNvPr>
              <p:cNvSpPr txBox="1"/>
              <p:nvPr/>
            </p:nvSpPr>
            <p:spPr>
              <a:xfrm>
                <a:off x="3599122" y="-2064007"/>
                <a:ext cx="5158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in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CB9181E-638C-CC4D-8BC5-B9BC04302598}"/>
                  </a:ext>
                </a:extLst>
              </p:cNvPr>
              <p:cNvSpPr txBox="1"/>
              <p:nvPr/>
            </p:nvSpPr>
            <p:spPr>
              <a:xfrm>
                <a:off x="355687" y="-3623187"/>
                <a:ext cx="8866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1640E289-ABC4-DD4D-9E6A-04E1AC8CE323}"/>
              </a:ext>
            </a:extLst>
          </p:cNvPr>
          <p:cNvGrpSpPr/>
          <p:nvPr/>
        </p:nvGrpSpPr>
        <p:grpSpPr>
          <a:xfrm>
            <a:off x="-40449" y="214046"/>
            <a:ext cx="4449102" cy="3864792"/>
            <a:chOff x="1071840" y="-133976"/>
            <a:chExt cx="4449102" cy="3864792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B1CB14A1-A12B-0F4A-BADB-CAAAF3A1E7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56449" b="20952"/>
            <a:stretch/>
          </p:blipFill>
          <p:spPr>
            <a:xfrm>
              <a:off x="3011844" y="52733"/>
              <a:ext cx="2300566" cy="3633732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93C9B04-84D1-C246-855D-0AABCAFA9727}"/>
                </a:ext>
              </a:extLst>
            </p:cNvPr>
            <p:cNvSpPr txBox="1"/>
            <p:nvPr/>
          </p:nvSpPr>
          <p:spPr>
            <a:xfrm>
              <a:off x="1071840" y="-133976"/>
              <a:ext cx="8866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DC029E16-3AB2-254F-853A-852485D13D65}"/>
                </a:ext>
              </a:extLst>
            </p:cNvPr>
            <p:cNvSpPr/>
            <p:nvPr/>
          </p:nvSpPr>
          <p:spPr>
            <a:xfrm>
              <a:off x="4051319" y="961534"/>
              <a:ext cx="599881" cy="261234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21437C47-3F76-6048-9023-118C6E0E9CAF}"/>
                </a:ext>
              </a:extLst>
            </p:cNvPr>
            <p:cNvSpPr/>
            <p:nvPr/>
          </p:nvSpPr>
          <p:spPr>
            <a:xfrm>
              <a:off x="4642137" y="965923"/>
              <a:ext cx="551734" cy="260795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CF758E8-0347-A845-91E3-C325A076BA38}"/>
                </a:ext>
              </a:extLst>
            </p:cNvPr>
            <p:cNvSpPr txBox="1"/>
            <p:nvPr/>
          </p:nvSpPr>
          <p:spPr>
            <a:xfrm>
              <a:off x="3794135" y="700957"/>
              <a:ext cx="17268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ame (3662 transcripts)</a:t>
              </a:r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F72F9614-ECE4-DF41-87E6-3748F1D5B51A}"/>
                </a:ext>
              </a:extLst>
            </p:cNvPr>
            <p:cNvGrpSpPr/>
            <p:nvPr/>
          </p:nvGrpSpPr>
          <p:grpSpPr>
            <a:xfrm>
              <a:off x="4051319" y="3615829"/>
              <a:ext cx="570348" cy="114987"/>
              <a:chOff x="2491845" y="3558499"/>
              <a:chExt cx="570348" cy="114987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741D950E-01F4-C140-9BEA-F0DF361A750E}"/>
                  </a:ext>
                </a:extLst>
              </p:cNvPr>
              <p:cNvSpPr/>
              <p:nvPr/>
            </p:nvSpPr>
            <p:spPr>
              <a:xfrm>
                <a:off x="2491845" y="3558499"/>
                <a:ext cx="284720" cy="114987"/>
              </a:xfrm>
              <a:prstGeom prst="rect">
                <a:avLst/>
              </a:prstGeom>
              <a:solidFill>
                <a:srgbClr val="FFC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BBF51175-D078-A146-9F02-B04546E5F8F6}"/>
                  </a:ext>
                </a:extLst>
              </p:cNvPr>
              <p:cNvSpPr/>
              <p:nvPr/>
            </p:nvSpPr>
            <p:spPr>
              <a:xfrm>
                <a:off x="2776565" y="3558499"/>
                <a:ext cx="285628" cy="114987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1CAC7138-A391-CB42-B780-FCB070701378}"/>
                </a:ext>
              </a:extLst>
            </p:cNvPr>
            <p:cNvGrpSpPr/>
            <p:nvPr/>
          </p:nvGrpSpPr>
          <p:grpSpPr>
            <a:xfrm>
              <a:off x="4651200" y="3615828"/>
              <a:ext cx="570348" cy="114987"/>
              <a:chOff x="2491845" y="3558499"/>
              <a:chExt cx="570348" cy="114987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2D72EED2-0C86-AA4F-868E-7CEFD4E8419A}"/>
                  </a:ext>
                </a:extLst>
              </p:cNvPr>
              <p:cNvSpPr/>
              <p:nvPr/>
            </p:nvSpPr>
            <p:spPr>
              <a:xfrm>
                <a:off x="2491845" y="3558499"/>
                <a:ext cx="284720" cy="114987"/>
              </a:xfrm>
              <a:prstGeom prst="rect">
                <a:avLst/>
              </a:prstGeom>
              <a:solidFill>
                <a:srgbClr val="FFC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CAA948C3-2101-2946-9F40-D00340271B25}"/>
                  </a:ext>
                </a:extLst>
              </p:cNvPr>
              <p:cNvSpPr/>
              <p:nvPr/>
            </p:nvSpPr>
            <p:spPr>
              <a:xfrm>
                <a:off x="2776565" y="3558499"/>
                <a:ext cx="285628" cy="114987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</p:grpSp>
      <p:pic>
        <p:nvPicPr>
          <p:cNvPr id="28" name="Picture 27">
            <a:extLst>
              <a:ext uri="{FF2B5EF4-FFF2-40B4-BE49-F238E27FC236}">
                <a16:creationId xmlns:a16="http://schemas.microsoft.com/office/drawing/2014/main" id="{1A54269F-AEF5-BD4A-9445-0C228CEB63E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09387" y="5921884"/>
            <a:ext cx="1910370" cy="150625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28AAB69C-7A2F-7042-8C63-770309D9B7C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146" y="5873225"/>
            <a:ext cx="1967383" cy="155120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4175D1B9-6AE5-6849-BB41-3DDB17D397F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76322" y="4415999"/>
            <a:ext cx="1881239" cy="148328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3732F4F8-6731-344E-8B22-BBC78823E25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96763" y="4484234"/>
            <a:ext cx="1736819" cy="136941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0AF7237-AFFA-9F44-AE57-CF57FF56C1E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5605" y="4398965"/>
            <a:ext cx="1846324" cy="1480313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3F2A5C4C-6F24-944F-9947-39B51D77B8B7}"/>
              </a:ext>
            </a:extLst>
          </p:cNvPr>
          <p:cNvSpPr txBox="1"/>
          <p:nvPr/>
        </p:nvSpPr>
        <p:spPr>
          <a:xfrm>
            <a:off x="541294" y="5346228"/>
            <a:ext cx="1086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91DFD17-5F55-D946-90D3-CBF09DE5D419}"/>
              </a:ext>
            </a:extLst>
          </p:cNvPr>
          <p:cNvSpPr txBox="1"/>
          <p:nvPr/>
        </p:nvSpPr>
        <p:spPr>
          <a:xfrm>
            <a:off x="2122841" y="5306157"/>
            <a:ext cx="1086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4A268D4-322F-EE43-B727-FF69ABDDA481}"/>
              </a:ext>
            </a:extLst>
          </p:cNvPr>
          <p:cNvSpPr txBox="1"/>
          <p:nvPr/>
        </p:nvSpPr>
        <p:spPr>
          <a:xfrm>
            <a:off x="2089776" y="6800285"/>
            <a:ext cx="1086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536B5E7-BCB8-7B44-8108-D17757E76B3D}"/>
              </a:ext>
            </a:extLst>
          </p:cNvPr>
          <p:cNvSpPr txBox="1"/>
          <p:nvPr/>
        </p:nvSpPr>
        <p:spPr>
          <a:xfrm>
            <a:off x="541294" y="6800285"/>
            <a:ext cx="1086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am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333BD02-4C8F-C44B-A57B-49EBE819EB94}"/>
              </a:ext>
            </a:extLst>
          </p:cNvPr>
          <p:cNvSpPr txBox="1"/>
          <p:nvPr/>
        </p:nvSpPr>
        <p:spPr>
          <a:xfrm>
            <a:off x="3646713" y="5317587"/>
            <a:ext cx="1086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1FD2F56-B89D-A242-B70A-01D9F8479384}"/>
              </a:ext>
            </a:extLst>
          </p:cNvPr>
          <p:cNvSpPr txBox="1"/>
          <p:nvPr/>
        </p:nvSpPr>
        <p:spPr>
          <a:xfrm>
            <a:off x="3653745" y="6837396"/>
            <a:ext cx="1086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9D449C0-3273-AE4C-8072-2BA7A1BABA7E}"/>
              </a:ext>
            </a:extLst>
          </p:cNvPr>
          <p:cNvSpPr txBox="1"/>
          <p:nvPr/>
        </p:nvSpPr>
        <p:spPr>
          <a:xfrm>
            <a:off x="-37270" y="4061042"/>
            <a:ext cx="8866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898F89F1-7582-D642-8170-99960964CAE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590202" y="1766879"/>
            <a:ext cx="1107693" cy="146751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7523705-E485-5142-9D9D-581BD744441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4739" y="489330"/>
            <a:ext cx="1542024" cy="154202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8FCFF135-8DD1-5D40-AEED-45410384F609}"/>
              </a:ext>
            </a:extLst>
          </p:cNvPr>
          <p:cNvSpPr txBox="1"/>
          <p:nvPr/>
        </p:nvSpPr>
        <p:spPr>
          <a:xfrm>
            <a:off x="142979" y="2051526"/>
            <a:ext cx="13493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328ECB9-653E-0C43-A7EC-4B464321D397}"/>
              </a:ext>
            </a:extLst>
          </p:cNvPr>
          <p:cNvSpPr txBox="1"/>
          <p:nvPr/>
        </p:nvSpPr>
        <p:spPr>
          <a:xfrm rot="16200000">
            <a:off x="-581579" y="1293780"/>
            <a:ext cx="13493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EpCAM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588B6428-115E-224C-8AE9-BDBF21FED19C}"/>
              </a:ext>
            </a:extLst>
          </p:cNvPr>
          <p:cNvCxnSpPr/>
          <p:nvPr/>
        </p:nvCxnSpPr>
        <p:spPr>
          <a:xfrm>
            <a:off x="575524" y="2174636"/>
            <a:ext cx="101808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D166E19D-79F8-374F-90B5-B63BE3B73C7A}"/>
              </a:ext>
            </a:extLst>
          </p:cNvPr>
          <p:cNvCxnSpPr>
            <a:cxnSpLocks/>
          </p:cNvCxnSpPr>
          <p:nvPr/>
        </p:nvCxnSpPr>
        <p:spPr>
          <a:xfrm flipV="1">
            <a:off x="115072" y="737828"/>
            <a:ext cx="0" cy="8084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95F8AC82-B0F4-924C-A6A7-6A346E1E9B23}"/>
              </a:ext>
            </a:extLst>
          </p:cNvPr>
          <p:cNvSpPr txBox="1"/>
          <p:nvPr/>
        </p:nvSpPr>
        <p:spPr>
          <a:xfrm>
            <a:off x="535935" y="522384"/>
            <a:ext cx="9738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0.3%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9B1B6A4-8018-C542-9940-55CFC2BCCB19}"/>
              </a:ext>
            </a:extLst>
          </p:cNvPr>
          <p:cNvSpPr txBox="1"/>
          <p:nvPr/>
        </p:nvSpPr>
        <p:spPr>
          <a:xfrm>
            <a:off x="4241920" y="162243"/>
            <a:ext cx="8866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325E67F-0C86-9E4C-8368-9D70CB8E0016}"/>
              </a:ext>
            </a:extLst>
          </p:cNvPr>
          <p:cNvSpPr txBox="1"/>
          <p:nvPr/>
        </p:nvSpPr>
        <p:spPr>
          <a:xfrm>
            <a:off x="343450" y="2429614"/>
            <a:ext cx="948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le secretion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6B179D3-2992-3D45-9D6D-966068E908D1}"/>
              </a:ext>
            </a:extLst>
          </p:cNvPr>
          <p:cNvSpPr txBox="1"/>
          <p:nvPr/>
        </p:nvSpPr>
        <p:spPr>
          <a:xfrm>
            <a:off x="1580634" y="2446634"/>
            <a:ext cx="13583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ineral absorptio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67DC3A7-B8BB-8945-A041-936283B10DF5}"/>
              </a:ext>
            </a:extLst>
          </p:cNvPr>
          <p:cNvSpPr txBox="1"/>
          <p:nvPr/>
        </p:nvSpPr>
        <p:spPr>
          <a:xfrm>
            <a:off x="-30033" y="2290799"/>
            <a:ext cx="8866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7D8FB959-0220-C943-90AF-45049D017F9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734805" y="5938918"/>
            <a:ext cx="1746307" cy="1453778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07F2164A-28B9-D746-A5DC-9C74AB2473E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1727" y="2663327"/>
            <a:ext cx="1317313" cy="1194149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E64E4E56-1CDF-3842-96C0-D0EB9AEF9A5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422918" y="2716717"/>
            <a:ext cx="1257386" cy="11449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06038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18CDA5-691C-4940-908F-A63F78600C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4814" y="285149"/>
            <a:ext cx="5915025" cy="258861"/>
          </a:xfrm>
        </p:spPr>
        <p:txBody>
          <a:bodyPr>
            <a:norm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ver clock gene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F2E0D22-377C-A649-8C6F-1AFD074562C7}"/>
              </a:ext>
            </a:extLst>
          </p:cNvPr>
          <p:cNvSpPr txBox="1"/>
          <p:nvPr/>
        </p:nvSpPr>
        <p:spPr>
          <a:xfrm>
            <a:off x="-30259" y="-14561"/>
            <a:ext cx="23186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F7610EC-D5CC-9244-96D1-1529BDA440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397" y="650988"/>
            <a:ext cx="2313396" cy="16348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F0B1650-DA05-9746-84A2-969C9DAAC7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06922" y="597499"/>
            <a:ext cx="2769730" cy="170071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27A7BCC-B70A-8E49-83E1-B7004F8195A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74581" y="624243"/>
            <a:ext cx="2749500" cy="168828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29AB51A-EB80-8E4A-90C8-EFF60FBD0276}"/>
              </a:ext>
            </a:extLst>
          </p:cNvPr>
          <p:cNvSpPr txBox="1"/>
          <p:nvPr/>
        </p:nvSpPr>
        <p:spPr>
          <a:xfrm>
            <a:off x="488368" y="817896"/>
            <a:ext cx="1509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eding effect NS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ime effect ***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action N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410C000-872A-F647-8C6D-CC0379F4572F}"/>
              </a:ext>
            </a:extLst>
          </p:cNvPr>
          <p:cNvSpPr txBox="1"/>
          <p:nvPr/>
        </p:nvSpPr>
        <p:spPr>
          <a:xfrm>
            <a:off x="3367199" y="751699"/>
            <a:ext cx="1509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eding effect NS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ime effect ***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action *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5433775-98E6-194E-91CA-CB64C1136504}"/>
              </a:ext>
            </a:extLst>
          </p:cNvPr>
          <p:cNvSpPr txBox="1"/>
          <p:nvPr/>
        </p:nvSpPr>
        <p:spPr>
          <a:xfrm>
            <a:off x="5674537" y="750605"/>
            <a:ext cx="1509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eding effect NS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ime effect ***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teraction *</a:t>
            </a:r>
          </a:p>
        </p:txBody>
      </p:sp>
    </p:spTree>
    <p:extLst>
      <p:ext uri="{BB962C8B-B14F-4D97-AF65-F5344CB8AC3E}">
        <p14:creationId xmlns:p14="http://schemas.microsoft.com/office/powerpoint/2010/main" val="22205791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8434235-3801-474D-A929-3B2D3AC78946}"/>
              </a:ext>
            </a:extLst>
          </p:cNvPr>
          <p:cNvSpPr txBox="1"/>
          <p:nvPr/>
        </p:nvSpPr>
        <p:spPr>
          <a:xfrm>
            <a:off x="142875" y="71438"/>
            <a:ext cx="60579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7EABD96-64D1-9746-9109-DB9A7F9F5771}"/>
              </a:ext>
            </a:extLst>
          </p:cNvPr>
          <p:cNvSpPr txBox="1"/>
          <p:nvPr/>
        </p:nvSpPr>
        <p:spPr>
          <a:xfrm>
            <a:off x="0" y="493521"/>
            <a:ext cx="8866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E43D808-A282-884C-85B1-C516B1575DBF}"/>
              </a:ext>
            </a:extLst>
          </p:cNvPr>
          <p:cNvSpPr txBox="1"/>
          <p:nvPr/>
        </p:nvSpPr>
        <p:spPr>
          <a:xfrm>
            <a:off x="3102701" y="571686"/>
            <a:ext cx="8866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9C9378B-F519-AE46-A83E-DF8C1ACA6A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65118" y="643175"/>
            <a:ext cx="2152351" cy="199225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D9AB1C0-8B7E-6141-91C5-EE98C9BB9570}"/>
              </a:ext>
            </a:extLst>
          </p:cNvPr>
          <p:cNvSpPr txBox="1"/>
          <p:nvPr/>
        </p:nvSpPr>
        <p:spPr>
          <a:xfrm>
            <a:off x="3723831" y="2035486"/>
            <a:ext cx="1086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1103A18-248A-7745-ABE1-C0753760E9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594541" y="192180"/>
            <a:ext cx="1896736" cy="29897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6899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0B6EE1D-E689-40A2-55C2-FFA020F65E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6945" y="605139"/>
            <a:ext cx="2005419" cy="184831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566C4A2-CB68-E01A-6E6B-0D3A410018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72569" y="616191"/>
            <a:ext cx="2856940" cy="18372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A9A0F6E-4C7D-5B0C-3683-4F0CC0F4AFAA}"/>
              </a:ext>
            </a:extLst>
          </p:cNvPr>
          <p:cNvSpPr txBox="1"/>
          <p:nvPr/>
        </p:nvSpPr>
        <p:spPr>
          <a:xfrm>
            <a:off x="2469135" y="448107"/>
            <a:ext cx="902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d libitu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E84CDD-A540-E151-1A32-FCF37E5037F3}"/>
              </a:ext>
            </a:extLst>
          </p:cNvPr>
          <p:cNvSpPr txBox="1"/>
          <p:nvPr/>
        </p:nvSpPr>
        <p:spPr>
          <a:xfrm>
            <a:off x="4195748" y="448106"/>
            <a:ext cx="902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terval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AEF4C02-F43A-2443-A4A0-890EA09DEF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8035" y="3213090"/>
            <a:ext cx="1689895" cy="125891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3E79145-BA72-FE4F-910E-1C3D1D3A56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39554" y="3323570"/>
            <a:ext cx="1710691" cy="117170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A2FE091-5F37-314C-83AA-EA99457530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0245" y="3305394"/>
            <a:ext cx="1684384" cy="115368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D68EEB2-42A5-E14D-A426-6BADD9C8DF1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7087" y="4886562"/>
            <a:ext cx="1746713" cy="1031616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2E32998-E052-6F49-B443-B88D4706F66F}"/>
              </a:ext>
            </a:extLst>
          </p:cNvPr>
          <p:cNvSpPr txBox="1"/>
          <p:nvPr/>
        </p:nvSpPr>
        <p:spPr>
          <a:xfrm>
            <a:off x="142875" y="71438"/>
            <a:ext cx="60579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D0AE70E-83C2-2E41-AC08-11DB7B1DD417}"/>
              </a:ext>
            </a:extLst>
          </p:cNvPr>
          <p:cNvSpPr txBox="1"/>
          <p:nvPr/>
        </p:nvSpPr>
        <p:spPr>
          <a:xfrm>
            <a:off x="-19149" y="352267"/>
            <a:ext cx="354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9419DF5-956E-6D45-BCE8-B9E74A1FD6B1}"/>
              </a:ext>
            </a:extLst>
          </p:cNvPr>
          <p:cNvSpPr txBox="1"/>
          <p:nvPr/>
        </p:nvSpPr>
        <p:spPr>
          <a:xfrm>
            <a:off x="1504531" y="374044"/>
            <a:ext cx="354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ACAA8DF-643A-9742-B660-61E9FB8B9B4C}"/>
              </a:ext>
            </a:extLst>
          </p:cNvPr>
          <p:cNvSpPr txBox="1"/>
          <p:nvPr/>
        </p:nvSpPr>
        <p:spPr>
          <a:xfrm>
            <a:off x="-19150" y="2838906"/>
            <a:ext cx="354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B488FF2-B5A5-034B-ADE2-F8B1558BD5F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7431" y="695811"/>
            <a:ext cx="1188956" cy="1766449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F65DDDC6-FB92-2D46-BCA0-635D28BE81B1}"/>
              </a:ext>
            </a:extLst>
          </p:cNvPr>
          <p:cNvSpPr txBox="1"/>
          <p:nvPr/>
        </p:nvSpPr>
        <p:spPr>
          <a:xfrm>
            <a:off x="334855" y="2926112"/>
            <a:ext cx="17583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TU_22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ctobacillus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gasseri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79DF225-FBF5-F64F-88CA-1499C931EF63}"/>
              </a:ext>
            </a:extLst>
          </p:cNvPr>
          <p:cNvSpPr txBox="1"/>
          <p:nvPr/>
        </p:nvSpPr>
        <p:spPr>
          <a:xfrm>
            <a:off x="2097122" y="2955564"/>
            <a:ext cx="17583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TU_104 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Oscillibacter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C4E56B3-FF54-474B-8B6C-6861A3270077}"/>
              </a:ext>
            </a:extLst>
          </p:cNvPr>
          <p:cNvSpPr txBox="1"/>
          <p:nvPr/>
        </p:nvSpPr>
        <p:spPr>
          <a:xfrm>
            <a:off x="3724938" y="2926112"/>
            <a:ext cx="18437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TU_377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lostridiales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vadin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BB60 group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5F61A1E-4E87-C946-A7C9-31524ECB50BC}"/>
              </a:ext>
            </a:extLst>
          </p:cNvPr>
          <p:cNvSpPr txBox="1"/>
          <p:nvPr/>
        </p:nvSpPr>
        <p:spPr>
          <a:xfrm>
            <a:off x="378999" y="4540527"/>
            <a:ext cx="2251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TU_145 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Lachnospiraceae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NK4A136 group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CF3888E-2AB3-4147-812C-F84470AE3E17}"/>
              </a:ext>
            </a:extLst>
          </p:cNvPr>
          <p:cNvSpPr txBox="1"/>
          <p:nvPr/>
        </p:nvSpPr>
        <p:spPr>
          <a:xfrm>
            <a:off x="2281984" y="4548008"/>
            <a:ext cx="20904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TU_13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abacteroides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goldsteinii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599260EA-A6F0-DD4A-BDD4-B7B6D09938F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33378" y="4750999"/>
            <a:ext cx="1723041" cy="11564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5824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55F13D31-D0E7-2D0A-5604-B338081DD53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42860756"/>
              </p:ext>
            </p:extLst>
          </p:nvPr>
        </p:nvGraphicFramePr>
        <p:xfrm>
          <a:off x="492270" y="554038"/>
          <a:ext cx="5057192" cy="3230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23696">
                  <a:extLst>
                    <a:ext uri="{9D8B030D-6E8A-4147-A177-3AD203B41FA5}">
                      <a16:colId xmlns:a16="http://schemas.microsoft.com/office/drawing/2014/main" val="1251609889"/>
                    </a:ext>
                  </a:extLst>
                </a:gridCol>
                <a:gridCol w="662151">
                  <a:extLst>
                    <a:ext uri="{9D8B030D-6E8A-4147-A177-3AD203B41FA5}">
                      <a16:colId xmlns:a16="http://schemas.microsoft.com/office/drawing/2014/main" val="3702505530"/>
                    </a:ext>
                  </a:extLst>
                </a:gridCol>
                <a:gridCol w="599090">
                  <a:extLst>
                    <a:ext uri="{9D8B030D-6E8A-4147-A177-3AD203B41FA5}">
                      <a16:colId xmlns:a16="http://schemas.microsoft.com/office/drawing/2014/main" val="1319595033"/>
                    </a:ext>
                  </a:extLst>
                </a:gridCol>
                <a:gridCol w="630621">
                  <a:extLst>
                    <a:ext uri="{9D8B030D-6E8A-4147-A177-3AD203B41FA5}">
                      <a16:colId xmlns:a16="http://schemas.microsoft.com/office/drawing/2014/main" val="1583642183"/>
                    </a:ext>
                  </a:extLst>
                </a:gridCol>
                <a:gridCol w="638503">
                  <a:extLst>
                    <a:ext uri="{9D8B030D-6E8A-4147-A177-3AD203B41FA5}">
                      <a16:colId xmlns:a16="http://schemas.microsoft.com/office/drawing/2014/main" val="4054942620"/>
                    </a:ext>
                  </a:extLst>
                </a:gridCol>
                <a:gridCol w="1403131">
                  <a:extLst>
                    <a:ext uri="{9D8B030D-6E8A-4147-A177-3AD203B41FA5}">
                      <a16:colId xmlns:a16="http://schemas.microsoft.com/office/drawing/2014/main" val="4191349504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FA</a:t>
                      </a: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 libitum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val Fed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Way ANOV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613724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H.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H.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57660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tic aci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eding N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N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action N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926938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tyrat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eding N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N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action N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19871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roic aci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eding N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*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action N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299972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prionic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eding N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N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action N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505882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eric aci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eding NS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*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action N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9204894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BC9C4E1-AA47-DE4F-B5EC-25221964D548}"/>
              </a:ext>
            </a:extLst>
          </p:cNvPr>
          <p:cNvSpPr txBox="1"/>
          <p:nvPr/>
        </p:nvSpPr>
        <p:spPr>
          <a:xfrm>
            <a:off x="0" y="0"/>
            <a:ext cx="68025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aeca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hort chain fatty acids (SCFAs) under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d libitum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interval feeding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JTK_Cycl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alysis of 24h periodicity under each feeding condition and between group comparisons using 2 Way ANOVA. </a:t>
            </a:r>
          </a:p>
        </p:txBody>
      </p:sp>
    </p:spTree>
    <p:extLst>
      <p:ext uri="{BB962C8B-B14F-4D97-AF65-F5344CB8AC3E}">
        <p14:creationId xmlns:p14="http://schemas.microsoft.com/office/powerpoint/2010/main" val="30601750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D3725EB-3551-2543-9241-6BFE8401FCD9}"/>
              </a:ext>
            </a:extLst>
          </p:cNvPr>
          <p:cNvSpPr txBox="1"/>
          <p:nvPr/>
        </p:nvSpPr>
        <p:spPr>
          <a:xfrm>
            <a:off x="0" y="0"/>
            <a:ext cx="680258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QPCR primers and probes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2272B251-09EE-1D4D-8E47-3854E39EDC7B}"/>
              </a:ext>
            </a:extLst>
          </p:cNvPr>
          <p:cNvGraphicFramePr>
            <a:graphicFrameLocks noGrp="1"/>
          </p:cNvGraphicFramePr>
          <p:nvPr/>
        </p:nvGraphicFramePr>
        <p:xfrm>
          <a:off x="715992" y="918713"/>
          <a:ext cx="5926546" cy="224219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34739">
                  <a:extLst>
                    <a:ext uri="{9D8B030D-6E8A-4147-A177-3AD203B41FA5}">
                      <a16:colId xmlns:a16="http://schemas.microsoft.com/office/drawing/2014/main" val="3579809951"/>
                    </a:ext>
                  </a:extLst>
                </a:gridCol>
                <a:gridCol w="1471448">
                  <a:extLst>
                    <a:ext uri="{9D8B030D-6E8A-4147-A177-3AD203B41FA5}">
                      <a16:colId xmlns:a16="http://schemas.microsoft.com/office/drawing/2014/main" val="598853484"/>
                    </a:ext>
                  </a:extLst>
                </a:gridCol>
                <a:gridCol w="1776249">
                  <a:extLst>
                    <a:ext uri="{9D8B030D-6E8A-4147-A177-3AD203B41FA5}">
                      <a16:colId xmlns:a16="http://schemas.microsoft.com/office/drawing/2014/main" val="2909303634"/>
                    </a:ext>
                  </a:extLst>
                </a:gridCol>
                <a:gridCol w="2144110">
                  <a:extLst>
                    <a:ext uri="{9D8B030D-6E8A-4147-A177-3AD203B41FA5}">
                      <a16:colId xmlns:a16="http://schemas.microsoft.com/office/drawing/2014/main" val="359085802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(FAM-TAMRA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1899394"/>
                  </a:ext>
                </a:extLst>
              </a:tr>
              <a:tr h="25319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-actin</a:t>
                      </a:r>
                    </a:p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C CAC AGG ATT CCA TAC CCA AGA AG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G TCA TCA CTA TTG GCA ACG 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C TTC ATG ATG GAA TTG AAT GTA GT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395559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mal1</a:t>
                      </a:r>
                    </a:p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A CCC TCA TGG AAG GTT AGA ATA TGC AGA 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A AGA AAG TAT GGA CAC AGA CAA 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A TTC TTG ATC CTT CCT TGG T</a:t>
                      </a:r>
                    </a:p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7110321"/>
                  </a:ext>
                </a:extLst>
              </a:tr>
              <a:tr h="42355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er2</a:t>
                      </a:r>
                    </a:p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 GCT CAC TAC TGC AGC CGC TCG 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C TTC AGA CTC ATG ATG ACA G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T GTG TGC GTC AGC TTT GG</a:t>
                      </a:r>
                    </a:p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00423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8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bp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A ACC TGA TCC GGC TGA TCT TGC 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G TGG AGG TGC TAA TGA CC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T CTG AGA AGC GGT GCC T</a:t>
                      </a:r>
                    </a:p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94631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1d1</a:t>
                      </a:r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mercial primer probe set (Mm</a:t>
                      </a:r>
                      <a:r>
                        <a:rPr lang="en-GB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0520708) from Applied Biosystems</a:t>
                      </a:r>
                    </a:p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08029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6939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</TotalTime>
  <Words>805</Words>
  <Application>Microsoft Macintosh PowerPoint</Application>
  <PresentationFormat>A4 Paper (210x297 mm)</PresentationFormat>
  <Paragraphs>186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Liver clock gene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Gibbs</dc:creator>
  <cp:lastModifiedBy>Julie Gibbs</cp:lastModifiedBy>
  <cp:revision>6</cp:revision>
  <dcterms:created xsi:type="dcterms:W3CDTF">2025-03-18T10:47:43Z</dcterms:created>
  <dcterms:modified xsi:type="dcterms:W3CDTF">2025-08-11T20:20:04Z</dcterms:modified>
</cp:coreProperties>
</file>